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60"/>
  </p:normalViewPr>
  <p:slideViewPr>
    <p:cSldViewPr snapToGrid="0">
      <p:cViewPr varScale="1">
        <p:scale>
          <a:sx n="118" d="100"/>
          <a:sy n="118" d="100"/>
        </p:scale>
        <p:origin x="55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FA7081-4714-DF6E-D1C4-CA67CC5507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E60163-2758-B381-3A1F-4EA8ADB160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51A9CF-5833-1DB8-81A2-5A29B48D1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B4F520-4E25-CD68-5FBA-0F8C3B745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F74861-EF51-E818-DF61-722883284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065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47A99B-A6ED-EB0C-413B-99F1EF1B37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F806D1-A1C9-77C7-A55C-B243195316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31D063-A440-AF4F-1CB0-912565F34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73954C-763F-8542-32AF-1EA9DB379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6BE994-3EFD-0468-3312-8D53E7173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90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834DC4-9DA2-6DDB-01B0-14F0C908F1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45DA8D-1C7D-A570-9F8D-EEB582FE92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88B23C-585C-09E0-EA53-6FFC14788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135F53-7BA8-3853-9863-35826537B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75A016-0585-00B3-1085-77264455E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725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C63AD2-0330-14FF-BF59-6737DCBEC1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D4E5F7-EE3C-A8BA-13F9-D592BF8B96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C962E4-DF73-8680-284F-04D787B00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855791-CE1C-65CC-740B-5F37FBE80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6BB75A-3BC6-DB35-33A3-83AA3F2E5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567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0912EB-C61F-4E85-C8A8-8487E0BB2D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181DCA-AD2E-2D11-A569-644EFFB329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8F6833-4399-6B69-4832-0A4C2B544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0ACF49-C01D-407F-E3B5-54D565BEA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B94A42-92C7-41E0-6868-023E81F17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427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57FD22-DDF6-CCA6-DFFE-3AFCA58B0C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4E7D0F-1CC7-ED11-EAA9-ED1D859695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F8874E-C85F-4F82-FAD4-2B2B880071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C18B8A-C549-57B8-B293-A8963872F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03E9F6-202E-1782-BF8E-961FEDF03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93352C-6CD6-0A01-9B52-95EFD7FE5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416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9AC0F-E4FC-9371-3F8A-3F73346EC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29ADD9-F757-2EF9-46C5-2BA1B0E70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537A4E-2D78-1B67-DD06-025E42F9DA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06F124-7DF3-BC39-C43D-C53C2E1427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CF2D4E-48B0-0F43-6D6D-DA5909D432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6A2657-44D5-3825-A268-A30BFE979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D13958-E084-59B8-EE72-0293F7071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6D5214-FED8-773E-2744-F42658C42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969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03B497-C4E5-6161-AA1E-31127A29A2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7125E4E-7B66-248E-B015-6D00B964D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005941-EF8F-16A9-C908-6DF7A4C60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BD4459-03BF-2AD2-5684-B46CD0346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401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D0C661-0B13-7D12-9963-8274FE604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8E2CA-F984-A5B0-8E41-E7FC5E01E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8CD959-E574-4080-AF16-8DBCE6529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87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ED0FE-5143-B7DE-898B-3CCDCEA5D1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68C52C-37AC-D011-3316-B9EFF98B0F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D5B6D3-4BB9-DDA1-3C73-2741EC3CAA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2FEA06-EDE2-5DEB-1819-B3ABDFD38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D1557E-03F3-01EF-0FC2-3584B6A11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5CE867-FD43-B82F-BC77-3832457D3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296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3D232-16CF-46C8-22E8-44A7A3E28A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E6CD76-F861-744E-DAFA-4F6BE5AC1E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2EBFF0-C8EB-5864-E7FE-A8FE342714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6E568F-2C1C-9E76-1A0A-54B3874D4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563F57-933D-1F26-675C-D1688D34A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758244-F4BA-8FA9-9A3A-D60EF39D4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562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96561EA-012A-0CE9-1352-CE31B2A696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FD9304-4C61-966A-B681-2015BD37F6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38CAE6-BDEB-2AD2-6FC1-098775D00F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D48A0C-66AC-0046-9FAB-08EE74461A57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508289-54D3-397E-7287-0A896D228A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1E042A-B061-50EA-F614-D1CFA4C6A8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A165F8-A4C8-B248-9B07-6B2672B67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753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bar graph with numbers and numbers&#10;&#10;Description automatically generated">
            <a:extLst>
              <a:ext uri="{FF2B5EF4-FFF2-40B4-BE49-F238E27FC236}">
                <a16:creationId xmlns:a16="http://schemas.microsoft.com/office/drawing/2014/main" id="{5459E942-223E-48D0-B2DA-5554435153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897212"/>
            <a:ext cx="2133600" cy="332422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368788C-071B-EB1E-32E4-5984FA4E61F3}"/>
              </a:ext>
            </a:extLst>
          </p:cNvPr>
          <p:cNvSpPr txBox="1"/>
          <p:nvPr/>
        </p:nvSpPr>
        <p:spPr>
          <a:xfrm>
            <a:off x="3694371" y="4170156"/>
            <a:ext cx="4973379" cy="8267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3. Loading control for the Western blots in Figure 3 of GAPDH for each of the myxoid liposarcoma cell lines: DDL-221, MLS-401-91, and MLS-1765-92. The antibody used was from Cell Signaling (97166S) at 1:500 dilution. The secondary antibody was Mouse-HRP from Protein Simple (105616). The cells were treated with either DMSO or SNS-032 for 6 hours and then run on the JESS system.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119DD9-E847-4220-505B-71A74F270E0F}"/>
              </a:ext>
            </a:extLst>
          </p:cNvPr>
          <p:cNvSpPr txBox="1"/>
          <p:nvPr/>
        </p:nvSpPr>
        <p:spPr>
          <a:xfrm>
            <a:off x="7922643" y="53164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uppl. Fig. 3</a:t>
            </a:r>
          </a:p>
        </p:txBody>
      </p:sp>
    </p:spTree>
    <p:extLst>
      <p:ext uri="{BB962C8B-B14F-4D97-AF65-F5344CB8AC3E}">
        <p14:creationId xmlns:p14="http://schemas.microsoft.com/office/powerpoint/2010/main" val="4175500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ird,Hannah C</dc:creator>
  <cp:lastModifiedBy>Beird,Hannah C</cp:lastModifiedBy>
  <cp:revision>1</cp:revision>
  <dcterms:created xsi:type="dcterms:W3CDTF">2026-03-24T14:08:15Z</dcterms:created>
  <dcterms:modified xsi:type="dcterms:W3CDTF">2026-03-24T14:08:56Z</dcterms:modified>
</cp:coreProperties>
</file>